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CD2CCB-7FD0-8884-F275-A2C8ED3CF8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3CD2AE-1F1D-3CDE-8851-A772195073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AAAB9C-7373-4BD9-D902-C929E03F9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E3A28A-2036-26CF-040B-669D2BFAB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1AB9A6-CE64-1CB9-6DB4-9562A4C70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927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F88D45-A00B-66B5-8907-52CEE9931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D9A1F9-119A-63A4-9B58-FDDB591457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5E7934-CC47-5DFF-7CF5-274D306B8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F5BED4-F973-7CFC-38D1-6B16B483B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532A29-4FE8-F4B8-AB1C-E5644D58C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167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92FFE3-C72A-0251-D8CE-45A0709DCB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24F043-5C16-ED6A-6F79-F5EB4E62FC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77A073-24B7-6B26-9CCE-4568CD77C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AEC7A0-E4AB-88AA-695E-144C36BEF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43D990-1210-C0A4-21D5-7B4168CDD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39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DE7B4-05DF-567B-B004-7CE2FEE779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AC2974-EBD5-36C1-CBAC-6560BC4893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D7CE71-93F0-82DC-2305-20284F80E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CE50C4-B532-76A4-2CCC-8E6B90BCD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09D32C-6803-833F-1B0F-549EA4D08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061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9B8FFE-BC2D-A3D0-65DC-CD91594888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2FF0D4-D292-46FA-A95A-C0CB262D11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A5D798-BAAA-B4BB-B601-8EC943BB6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7D80C5-D72F-AC24-2374-38CFA56CA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A9C5FC-8AB4-ACC5-FAD1-06C08B0C1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690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72ED9C-428B-F590-AF8F-28306C2C72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66607B-912A-B8C3-2C3E-57C3FB2E565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B8799F-8B05-D9EE-1E98-88ED09D653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561B05-725A-9D23-F42B-32C0F1E18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494AEF-1D28-769C-01CB-494D61830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AFFB91-D1FC-D452-2AB7-78F875454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655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BF1241-14CA-7C75-7B74-7C03189836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B86599-D862-5106-918C-527B680FA1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CC0EDE-83C2-CD2C-6BD5-A8D8E297BA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96B8EB-1634-43D3-EA1A-39CF41AE57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99CE5A-EF36-F20D-C02E-4727BFF89E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6D27E53-3B8C-2A89-BBE8-C794F7999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6CC7FC-EBC7-E339-035B-BE48C8A50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441E78-C523-4234-FB09-BF112FFA9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53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A99079-82D4-8C4D-28D6-4F6AADE581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881F3A-F3ED-0DAD-67F8-54E2AA945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A671C9-1061-8A78-FAE9-E6974977E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1328C4-B74F-CA32-40F6-52383842F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13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2AE2E0-CF32-DBCD-0D3D-DCA956AA2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55D8961-7862-FCDB-C58B-B4939B37B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9FB105-3F15-768D-9279-5F015E6FA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139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0E7B4B-060F-692D-D723-762B24AE4E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710CA5-2782-4434-664D-4F0FA0534D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EC3F9F-17A0-5365-BF89-9E87EAD92C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D52D10-21DF-F49A-B424-3800F3973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6F017A-A471-D019-1A15-9FFF7ADC8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F536DA-FADC-38AE-25FA-B02747534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376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10A66-B43C-8F7F-09DE-60CD536609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B5FD4D1-95F7-BE75-4D0F-31271B5C82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C0F5E4-3762-3463-EFDF-6D44520C33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5EF0C9-59F3-577E-9791-24A2D3473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89769C-6606-7F7B-60E5-54A3B0B73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4FBBD0-6F02-5F59-38D5-D1AF5A291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254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90A12C-6981-4335-039F-307774FA84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2576F9-9C52-4465-D058-20F70E7871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4EA331-752D-68E5-F090-03C6BE6D42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4A32C0-BBD0-4B48-9D70-2CD339F84C8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503715-7E5D-20D9-BA73-1140A41D47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C79B9D-8BA5-5AF4-B267-0BC58D6EB6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DFCCA1-0614-48E1-875E-98A827D551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63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086716" y="1154885"/>
            <a:ext cx="732359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11 Table. Down-regulated proteins are associated with neurological disease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1187078" y="1431884"/>
          <a:ext cx="6587612" cy="2235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35787">
                  <a:extLst>
                    <a:ext uri="{9D8B030D-6E8A-4147-A177-3AD203B41FA5}">
                      <a16:colId xmlns:a16="http://schemas.microsoft.com/office/drawing/2014/main" val="3338778181"/>
                    </a:ext>
                  </a:extLst>
                </a:gridCol>
                <a:gridCol w="892098">
                  <a:extLst>
                    <a:ext uri="{9D8B030D-6E8A-4147-A177-3AD203B41FA5}">
                      <a16:colId xmlns:a16="http://schemas.microsoft.com/office/drawing/2014/main" val="1486831895"/>
                    </a:ext>
                  </a:extLst>
                </a:gridCol>
                <a:gridCol w="1159727">
                  <a:extLst>
                    <a:ext uri="{9D8B030D-6E8A-4147-A177-3AD203B41FA5}">
                      <a16:colId xmlns:a16="http://schemas.microsoft.com/office/drawing/2014/main" val="2087893524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p</a:t>
                      </a:r>
                      <a:r>
                        <a:rPr lang="en-US" sz="1200" b="1" i="0" u="none" strike="noStrike" baseline="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0 significantly changed pathways 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-valu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52853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crophage Related Iron Uptake and Rele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6E-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98038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294495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myloid </a:t>
                      </a:r>
                      <a:r>
                        <a:rPr lang="el-GR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raffic and Degradation in in Alzheimer's Dise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6E-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9803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205086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oteins Involved in Frontotemporal Dementi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7E-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9803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356314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oteins Involved in Alzheimer's Dise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0E-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98038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358219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ndosomal Recycl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9E-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98038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483528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PCAM in Cancer Cell Motility and Prolifer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0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79135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786535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grins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 Cancer Cell Motility, Invasion and Surviv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5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4745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333648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st-Cell Activation in Asthm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70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4745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04830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ered Protein Expression in Cancer Metabolic  Reprogramm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84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47457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453770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st-Cell Activation via </a:t>
                      </a:r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E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ignal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98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47457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29827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02449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05:47Z</dcterms:created>
  <dcterms:modified xsi:type="dcterms:W3CDTF">2025-07-28T20:06:14Z</dcterms:modified>
</cp:coreProperties>
</file>